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5958"/>
    <p:restoredTop sz="96029"/>
  </p:normalViewPr>
  <p:slideViewPr>
    <p:cSldViewPr snapToGrid="0" snapToObjects="1">
      <p:cViewPr varScale="1">
        <p:scale>
          <a:sx n="81" d="100"/>
          <a:sy n="81" d="100"/>
        </p:scale>
        <p:origin x="2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292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319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38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6841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738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515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163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092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117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17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771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E2B95-8075-8B42-B4B3-C72B275FDE12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F2509-F86A-B140-A04A-110B2B0E6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4549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BA9D871B-849D-304A-B242-3A7CCBD778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7456999"/>
              </p:ext>
            </p:extLst>
          </p:nvPr>
        </p:nvGraphicFramePr>
        <p:xfrm>
          <a:off x="616222" y="912704"/>
          <a:ext cx="5625555" cy="5582704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1125111">
                  <a:extLst>
                    <a:ext uri="{9D8B030D-6E8A-4147-A177-3AD203B41FA5}">
                      <a16:colId xmlns:a16="http://schemas.microsoft.com/office/drawing/2014/main" val="657961013"/>
                    </a:ext>
                  </a:extLst>
                </a:gridCol>
                <a:gridCol w="1125111">
                  <a:extLst>
                    <a:ext uri="{9D8B030D-6E8A-4147-A177-3AD203B41FA5}">
                      <a16:colId xmlns:a16="http://schemas.microsoft.com/office/drawing/2014/main" val="2148206904"/>
                    </a:ext>
                  </a:extLst>
                </a:gridCol>
                <a:gridCol w="1125111">
                  <a:extLst>
                    <a:ext uri="{9D8B030D-6E8A-4147-A177-3AD203B41FA5}">
                      <a16:colId xmlns:a16="http://schemas.microsoft.com/office/drawing/2014/main" val="2127255170"/>
                    </a:ext>
                  </a:extLst>
                </a:gridCol>
                <a:gridCol w="1125111">
                  <a:extLst>
                    <a:ext uri="{9D8B030D-6E8A-4147-A177-3AD203B41FA5}">
                      <a16:colId xmlns:a16="http://schemas.microsoft.com/office/drawing/2014/main" val="2397390180"/>
                    </a:ext>
                  </a:extLst>
                </a:gridCol>
                <a:gridCol w="1125111">
                  <a:extLst>
                    <a:ext uri="{9D8B030D-6E8A-4147-A177-3AD203B41FA5}">
                      <a16:colId xmlns:a16="http://schemas.microsoft.com/office/drawing/2014/main" val="3495937354"/>
                    </a:ext>
                  </a:extLst>
                </a:gridCol>
              </a:tblGrid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1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CL1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MC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8U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ARF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795893756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X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ND4B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LRA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UD7A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UBE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3462727238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AP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ND5B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R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BPC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ISA9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886535614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CY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HCR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RC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X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19A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764677355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B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WD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TBP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DH1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25A4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3101202128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MS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H1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TBP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DHGA1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35G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214267617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N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PY19L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DCAM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SK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4A9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3192070477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PC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ICH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ML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E4DI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KA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140743630"/>
                  </a:ext>
                </a:extLst>
              </a:tr>
              <a:tr h="232498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KRD18A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V3-1-ZNF11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3K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GR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K11I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832661173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KRD36C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CGB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EZO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C1D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3178038376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P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X1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GF8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K3R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C1D9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884371268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G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S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IN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EM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221830053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FGEF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MO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KL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XNA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S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56752936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GE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XD4L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GAT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NPLA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M49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51837780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IAP2L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G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HFR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TED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M7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931055354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RD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E2C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1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TEE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BGCP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3789563031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NC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3A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FIA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BGCP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694070991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2CD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P6R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XNDC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108681520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6orf22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MD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5B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AM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XN1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526672469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S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A6L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DM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GC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097810977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DC140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A6L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A15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X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SP2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67273009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DC15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A8B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PF10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H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P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516801736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DC40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A8K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PF1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KAG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KR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867087066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A8R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PF20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R29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TS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3700943915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AP4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OR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SS1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HHC1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277235568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AP65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M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LGN4X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PR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41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577489103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T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CY1A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IPB15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PRZ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708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169024085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NTNAP3B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FN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RG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WP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71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710306299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4A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B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SC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RRES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71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34704334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4A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YNA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GFR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SSF10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72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972643047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B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NK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2T1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76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551062370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IPAK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NN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2T29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BDD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81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2464888581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MP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AA1324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2T8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1L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1886477437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TF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AP1-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4A5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RS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3237204252"/>
                  </a:ext>
                </a:extLst>
              </a:tr>
              <a:tr h="157359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DP1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AP4-1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5H1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AF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643" marR="6643" marT="6643" marB="0" anchor="ctr"/>
                </a:tc>
                <a:extLst>
                  <a:ext uri="{0D108BD9-81ED-4DB2-BD59-A6C34878D82A}">
                    <a16:rowId xmlns:a16="http://schemas.microsoft.com/office/drawing/2014/main" val="4210068223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5B89618-BEAF-B840-AC6B-E2C99384199C}"/>
              </a:ext>
            </a:extLst>
          </p:cNvPr>
          <p:cNvSpPr txBox="1"/>
          <p:nvPr/>
        </p:nvSpPr>
        <p:spPr>
          <a:xfrm>
            <a:off x="81562" y="437665"/>
            <a:ext cx="2304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1</a:t>
            </a: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560E535-620E-1F4A-B6B8-B8FC1C45D8FD}"/>
              </a:ext>
            </a:extLst>
          </p:cNvPr>
          <p:cNvSpPr/>
          <p:nvPr/>
        </p:nvSpPr>
        <p:spPr>
          <a:xfrm>
            <a:off x="0" y="6709720"/>
            <a:ext cx="671611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l </a:t>
            </a:r>
            <a:r>
              <a:rPr lang="en-US" altLang="ja-JP" b="1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Table S1: Len-R and Pom-R acquired 172 genes 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harboring unique non-silent mutations</a:t>
            </a:r>
            <a:r>
              <a:rPr lang="en-US" altLang="ja-JP" b="1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.</a:t>
            </a:r>
            <a:r>
              <a:rPr lang="en-US" altLang="ja-JP" b="1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</a:p>
          <a:p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172 genes harboring unique non-silent mutations in Len-R/ Pom-R MM cells</a:t>
            </a:r>
            <a:r>
              <a:rPr lang="en-US" altLang="ja-JP" b="1" dirty="0">
                <a:solidFill>
                  <a:srgbClr val="111111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were sorted out from the results of WES.</a:t>
            </a:r>
            <a:endParaRPr lang="ja-JP" altLang="ja-JP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987066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77</TotalTime>
  <Words>211</Words>
  <Application>Microsoft Macintosh PowerPoint</Application>
  <PresentationFormat>A4 210 x 297 mm</PresentationFormat>
  <Paragraphs>17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智章 森</dc:creator>
  <cp:lastModifiedBy>智章 森</cp:lastModifiedBy>
  <cp:revision>154</cp:revision>
  <dcterms:created xsi:type="dcterms:W3CDTF">2020-11-28T06:45:15Z</dcterms:created>
  <dcterms:modified xsi:type="dcterms:W3CDTF">2021-10-25T21:16:27Z</dcterms:modified>
</cp:coreProperties>
</file>